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3843D-8D24-4C27-B1A1-C4FD909546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D70D4-273C-4251-9B2D-45F83E502E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BD573-93E8-438B-BF42-1C53E9962B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A813C-FBC3-4D33-821F-6462EC9F7A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C27B9-FFA4-4AC7-ABBB-19B1519927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CEB1E-7071-4D9F-B2A6-B95274A19C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EA613-A4E7-48FD-A659-6F1EDE3471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70BFC-CC70-4F45-B24E-EC64C429FB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236618-8B8E-44DB-A9F2-AB340681BF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1426D-B4CE-4220-895C-E1B570FFC6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ED98E-7F6C-4700-9F11-315A164B7F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59CF6-90E2-4AA1-9834-F9A62D684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ED31D5-FB04-4761-A563-7A57BDE02DB3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324000" y="128520"/>
            <a:ext cx="3456000" cy="662796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2"/>
          <p:cNvSpPr/>
          <p:nvPr/>
        </p:nvSpPr>
        <p:spPr>
          <a:xfrm>
            <a:off x="3995640" y="476280"/>
            <a:ext cx="489744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4 Fig. miR-142-3p induces a change in cell morphology and actin cytoskeleton structure in MCF-7 cells.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Following transfection</a:t>
            </a: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with a negative control miRNA, miR-142-3p precursors (all from ABI), cells were processed for immunohistochemistry as described in the main manuscript using ALEXA555-phalloidin (Invitrogen, Eugene, OR, USA, 1:1000) for staining of actin filaments. miR-142-3p transfection induces a more rounded cell morphology and a more cortical actin distributi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5T06:18:10Z</dcterms:created>
  <dc:creator>Martin Götte</dc:creator>
  <dc:description/>
  <dc:language>en-US</dc:language>
  <cp:lastModifiedBy>Prof. Dr. Martin Götte</cp:lastModifiedBy>
  <dcterms:modified xsi:type="dcterms:W3CDTF">2015-11-16T14:53:44Z</dcterms:modified>
  <cp:revision>13</cp:revision>
  <dc:subject/>
  <dc:title>Folie 1</dc:title>
</cp:coreProperties>
</file>